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9"/>
  </p:notesMasterIdLst>
  <p:sldIdLst>
    <p:sldId id="261" r:id="rId5"/>
    <p:sldId id="256" r:id="rId6"/>
    <p:sldId id="260" r:id="rId7"/>
    <p:sldId id="258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295"/>
    <p:restoredTop sz="95787"/>
  </p:normalViewPr>
  <p:slideViewPr>
    <p:cSldViewPr snapToGrid="0" snapToObjects="1">
      <p:cViewPr varScale="1">
        <p:scale>
          <a:sx n="84" d="100"/>
          <a:sy n="84" d="100"/>
        </p:scale>
        <p:origin x="55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ableStyles" Target="tableStyle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heme" Target="theme/theme1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viewProps" Target="viewProps.xml"/><Relationship Id="rId5" Type="http://schemas.openxmlformats.org/officeDocument/2006/relationships/slide" Target="slides/slide1.xml"/><Relationship Id="rId10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E5766AA-2071-B344-9FA8-F558DEE169F1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FA4680-8A26-CC40-B7C2-7DED34FFB7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5315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FA4680-8A26-CC40-B7C2-7DED34FFB76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042471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4610A3-5476-344F-B9FF-DBD224FAD7D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1341205-A9F6-FC4E-8076-6D6FB56C09A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BAC381-C7D5-764A-9321-C128F4BC7B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260664-E439-0342-BEC8-ABBB1B4A8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F5A28-FFC1-B04D-A178-268E39AA5E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718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379715-EF36-0945-891B-0B7B1EB430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86854A-73E3-6B46-9973-D85FEFA7AC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072862-12C2-5943-A0BF-1B5339AFB8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7CF3BD-11FB-9B49-826D-4E7078AC6F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3B0EB6-D89A-F14F-836C-607559D74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08802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7DF4243-DEBD-CF41-B09D-C115AF8B0CE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368ECF-20A6-1F4E-97A7-DBB8B12A15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8FA1D7-7804-654E-ABE8-8D67143711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989A1C-9F9E-0340-ABEA-EC523CA68D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FEB74E-FF45-F14E-948A-2647AAFBC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5895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256B6D-AB5A-8442-88A3-024232273F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7378E5-6373-8A42-828A-515F698AE13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9B21868-EA50-2E4F-B741-E17C0B4AEC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12958D-AA79-A140-A3A1-29231FEAFC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7BE5A0-5A85-4344-B0B7-634BB4A34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037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936500-F085-2447-8952-0F5E1D1BE2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B33DFE-56BF-5E4D-8841-179C029443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494185-579E-4A42-938D-F4D1C8BDC5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DA2450-F460-8C4D-81F5-7DA03BA996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3506B6-0E5F-5341-96E7-1D444A8AF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0860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37A8C4-50AB-B543-B7B4-312C1EA15F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883168-3EEB-BC49-BA58-F593C5CF7D1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714E077-145C-4C46-A4DB-552EBB7978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D58503-7BE0-B645-8CEC-4F751E4B3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551948-1B53-BD42-8AD8-3061AAF36B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E66523-E114-0941-8D07-493C5FE459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44550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4BDEEB-BC9B-8843-BE88-7401E6338A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6CB0BA-95B5-E442-9F00-5EC00FED723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546DCD-E8B4-AB4C-A793-5C9DBF860A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A9FA322-58C5-FC40-AD6B-898231C0F3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22AB653-0CD4-7F48-A555-F620C74085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27E0CC0-FCAB-0D4C-AF73-7F3BF2E084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DA0EC8C-DBFD-FF46-992C-BB623CCC8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02411CF-C5E4-B34A-A404-EFF27E7664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93513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53359B-C350-9745-8758-E2EECB81C3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EB3F3D-B833-9346-9E8D-57268E187C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5E89CE5-BD3F-3C47-802E-47423FCA0D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C867940-7E88-E14D-AE5F-D0E2F7E3C5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583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083B01-6E11-6641-90B4-1E85416A0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75B6EB1-41FD-504A-A1E2-2CDA9ED972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DE56F0A-213D-C541-B120-29576717EF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906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4B2A1B-1CF1-5A4A-B4CC-E39CEBB5F9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65621D-153F-2F4B-8473-EB258A57E5A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AF8256-4611-AC47-9E4B-831B7278A2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1E1C625-B919-0248-BAED-0CB152B4A9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18B76F-93B6-8648-9223-7C1CC1EAC0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9D7227A-05F6-BC46-A291-F0251128EE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7018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21311F-1B4C-1043-9C6E-0E76317B24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5C0AF39-BC5E-7947-895F-4E27A452B85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C29254-3C4F-324C-AFA6-0578000A4B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2AC4D9-CBB9-E74A-8AC0-ED4C77EF05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F44DEB-EAE2-4544-9AD5-016E73A601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FE98EF-CC79-B644-AFBA-17F69E6B51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1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7FEB889-2C6F-644F-9586-FB410B10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7B9BD3-EE30-C74D-BB62-A60A023319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CCEEF0-BDD8-4144-8288-0503584BC6B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1B60B0-7049-B741-9764-A8A75C6D7444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C99531-0A0E-9A42-82AE-91208C3A9D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E078E4-5A90-E742-99A6-32663BF2D9F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AA4379-EB9B-4B42-91CC-5746486904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4776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04CCD94-8E5F-474C-81B1-7532C12BFE5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5717430"/>
            <a:ext cx="10515600" cy="961604"/>
          </a:xfrm>
        </p:spPr>
        <p:txBody>
          <a:bodyPr>
            <a:normAutofit fontScale="92500"/>
          </a:bodyPr>
          <a:lstStyle/>
          <a:p>
            <a:pPr marL="0" indent="0" algn="ctr">
              <a:buNone/>
            </a:pPr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pen reading frame search of of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er3856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tein homology in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er07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cluding 100 bp upstream. Other xanthomonads include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falfae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p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umeloni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1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i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FBP6369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85-10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an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1-118 and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an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V904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an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p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7-12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an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V839,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an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p2010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MG12749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 highlighted in red indicates open reading frame according to https://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b.expasy.org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translate/.</a:t>
            </a:r>
          </a:p>
          <a:p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FE7A8ED7-0363-734D-9A35-9E010D8D931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0142" y="118488"/>
            <a:ext cx="9050661" cy="55989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777551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F21310A-B10A-CB43-9133-7D63C85ED2DC}"/>
              </a:ext>
            </a:extLst>
          </p:cNvPr>
          <p:cNvSpPr txBox="1"/>
          <p:nvPr/>
        </p:nvSpPr>
        <p:spPr>
          <a:xfrm>
            <a:off x="927847" y="4703483"/>
            <a:ext cx="1005840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indent="-457200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2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rrangement and content of the xylanolytic enzyme cluster within differen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anthomona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mes including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V-rose-07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an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1-118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-10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falfae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p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umeloni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1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i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FBP6369,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MG12749,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C35937, and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rdner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CC19865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mbols ‘[’ and ‘]’ stand for the contig break.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r code represents homologues genes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1D7F3599-1649-1944-A0F3-C9B975FACC6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8100" y="436283"/>
            <a:ext cx="8331200" cy="4267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193822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62940926-217B-0849-85AF-CDE6BFE070D8}"/>
              </a:ext>
            </a:extLst>
          </p:cNvPr>
          <p:cNvSpPr txBox="1"/>
          <p:nvPr/>
        </p:nvSpPr>
        <p:spPr>
          <a:xfrm>
            <a:off x="874059" y="5363865"/>
            <a:ext cx="1051560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indent="-457200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3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arrangement and content of the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cs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xp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usters within differen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anthomona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mes including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V-rose-07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an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1-118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-10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falfae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p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umeloni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1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i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FBP6369,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MG12749,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C35937, and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rdner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CC19865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mbols ‘[’ and ‘]’ stand for the contig break.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r code represents for the different genes.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0AE1817B-034F-B74A-9F00-A6127C9A8B0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47800" y="753765"/>
            <a:ext cx="9296400" cy="4610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604923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1D66988-98D9-744B-BAB9-AF2464B5565A}"/>
              </a:ext>
            </a:extLst>
          </p:cNvPr>
          <p:cNvSpPr txBox="1"/>
          <p:nvPr/>
        </p:nvSpPr>
        <p:spPr>
          <a:xfrm>
            <a:off x="403412" y="5380672"/>
            <a:ext cx="1167204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457200" indent="-457200"/>
            <a: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4.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tructure of the LPS cluster within different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anthomona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omes including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V-rose-07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erforan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91-118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-10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falfae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bsp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umelonis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1,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i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FBP6369,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uvesicatoria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MG12749,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esicatoria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TCC35937, and 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 </a:t>
            </a:r>
            <a:r>
              <a:rPr lang="en-US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rdneri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TCC19865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,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ymbols ‘[’ and ‘]’ stand for the contig break.</a:t>
            </a:r>
            <a:r>
              <a:rPr lang="en-US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lor code represents homologous genes in different genomes. ‘</a:t>
            </a:r>
            <a:r>
              <a:rPr lang="en-US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po</a:t>
            </a:r>
            <a:r>
              <a:rPr 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ro’ indicates a hypothetical protein. 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9203437B-223A-8941-8068-B4D5254F60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95500" y="0"/>
            <a:ext cx="8001000" cy="5308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580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EF82C3EC38841043986D8156B337B3F1" ma:contentTypeVersion="4" ma:contentTypeDescription="Create a new document." ma:contentTypeScope="" ma:versionID="3a42667c522abdc7d5fefa89bbcba1de">
  <xsd:schema xmlns:xsd="http://www.w3.org/2001/XMLSchema" xmlns:xs="http://www.w3.org/2001/XMLSchema" xmlns:p="http://schemas.microsoft.com/office/2006/metadata/properties" xmlns:ns2="95eda9c5-117c-44c4-a4b8-52ede42d6b9a" targetNamespace="http://schemas.microsoft.com/office/2006/metadata/properties" ma:root="true" ma:fieldsID="7e9cb42e2ec37e08502c5a8c6079bd62" ns2:_="">
    <xsd:import namespace="95eda9c5-117c-44c4-a4b8-52ede42d6b9a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5eda9c5-117c-44c4-a4b8-52ede42d6b9a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D74646C5-A2D8-45B8-A8E3-197E7C344B47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570FFC64-DBF7-4697-9C04-88AA33DC9DE5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FBDB8C26-085C-4249-8237-C44CB37E2BD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5eda9c5-117c-44c4-a4b8-52ede42d6b9a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416</TotalTime>
  <Words>347</Words>
  <Application>Microsoft Office PowerPoint</Application>
  <PresentationFormat>Widescreen</PresentationFormat>
  <Paragraphs>5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imilsina,Sujan</dc:creator>
  <cp:lastModifiedBy>MDPI</cp:lastModifiedBy>
  <cp:revision>9</cp:revision>
  <dcterms:created xsi:type="dcterms:W3CDTF">2020-08-11T22:12:23Z</dcterms:created>
  <dcterms:modified xsi:type="dcterms:W3CDTF">2022-03-17T07:35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EF82C3EC38841043986D8156B337B3F1</vt:lpwstr>
  </property>
</Properties>
</file>